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7B2BF5-7A18-470E-8C94-4B372BC7B9E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5425CC-E525-416E-9715-9A840686D4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5963F3-0DE1-4178-95BE-8AC64A0997A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B33BC1-E518-496F-807E-8D9279B68C5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4F1833-182E-49F1-8BFC-39FE6B0D14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1FEDA6-8758-4859-B3A5-9FA805FF1B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8F115D-A9C4-4761-81DA-3562A34F3A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09F2EF-0B90-4846-AC32-1F763790ED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D03E7C-ECD5-445F-8621-6138AF44C4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BB7910-6A88-45BF-BC19-35276C7FED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1CD501-7EFF-45FD-8746-C77BCAF078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3755B9-9177-4684-9ACF-BF8817E99E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800ADDB-67F6-497C-9FA6-8F72BFD1705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705"/>
          <p:cNvGrpSpPr/>
          <p:nvPr/>
        </p:nvGrpSpPr>
        <p:grpSpPr>
          <a:xfrm>
            <a:off x="-4680" y="2157480"/>
            <a:ext cx="6138720" cy="215640"/>
            <a:chOff x="-4680" y="2157480"/>
            <a:chExt cx="6138720" cy="215640"/>
          </a:xfrm>
        </p:grpSpPr>
        <p:sp>
          <p:nvSpPr>
            <p:cNvPr id="42" name="Line 699"/>
            <p:cNvSpPr/>
            <p:nvPr/>
          </p:nvSpPr>
          <p:spPr>
            <a:xfrm flipV="1">
              <a:off x="1620720" y="2265120"/>
              <a:ext cx="190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Line 700"/>
            <p:cNvSpPr/>
            <p:nvPr/>
          </p:nvSpPr>
          <p:spPr>
            <a:xfrm>
              <a:off x="4521240" y="2263680"/>
              <a:ext cx="157644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701"/>
            <p:cNvSpPr/>
            <p:nvPr/>
          </p:nvSpPr>
          <p:spPr>
            <a:xfrm>
              <a:off x="1047600" y="2219040"/>
              <a:ext cx="42840" cy="853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520" bIns="38520" anchor="ctr">
              <a:no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Rectangle 702"/>
            <p:cNvSpPr/>
            <p:nvPr/>
          </p:nvSpPr>
          <p:spPr>
            <a:xfrm>
              <a:off x="6091200" y="2224080"/>
              <a:ext cx="42840" cy="853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520" bIns="38520" anchor="ctr">
              <a:no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703"/>
            <p:cNvSpPr/>
            <p:nvPr/>
          </p:nvSpPr>
          <p:spPr>
            <a:xfrm>
              <a:off x="-4680" y="2157480"/>
              <a:ext cx="1100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OWB-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Line 704"/>
            <p:cNvSpPr/>
            <p:nvPr/>
          </p:nvSpPr>
          <p:spPr>
            <a:xfrm flipV="1">
              <a:off x="1069920" y="2263320"/>
              <a:ext cx="50328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8" name="Text Box 456"/>
          <p:cNvSpPr/>
          <p:nvPr/>
        </p:nvSpPr>
        <p:spPr>
          <a:xfrm>
            <a:off x="1097280" y="1185840"/>
            <a:ext cx="34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k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425"/>
          <p:cNvSpPr/>
          <p:nvPr/>
        </p:nvSpPr>
        <p:spPr>
          <a:xfrm flipV="1">
            <a:off x="1047600" y="1265040"/>
            <a:ext cx="0" cy="7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426"/>
          <p:cNvSpPr/>
          <p:nvPr/>
        </p:nvSpPr>
        <p:spPr>
          <a:xfrm flipV="1">
            <a:off x="1504800" y="1265040"/>
            <a:ext cx="0" cy="7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427"/>
          <p:cNvSpPr/>
          <p:nvPr/>
        </p:nvSpPr>
        <p:spPr>
          <a:xfrm flipV="1">
            <a:off x="1962000" y="1265040"/>
            <a:ext cx="0" cy="7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428"/>
          <p:cNvSpPr/>
          <p:nvPr/>
        </p:nvSpPr>
        <p:spPr>
          <a:xfrm flipV="1">
            <a:off x="2419200" y="1265040"/>
            <a:ext cx="0" cy="7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429"/>
          <p:cNvSpPr/>
          <p:nvPr/>
        </p:nvSpPr>
        <p:spPr>
          <a:xfrm flipV="1">
            <a:off x="2876400" y="1265040"/>
            <a:ext cx="0" cy="7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430"/>
          <p:cNvSpPr/>
          <p:nvPr/>
        </p:nvSpPr>
        <p:spPr>
          <a:xfrm flipV="1">
            <a:off x="3333600" y="1265040"/>
            <a:ext cx="0" cy="7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431"/>
          <p:cNvSpPr/>
          <p:nvPr/>
        </p:nvSpPr>
        <p:spPr>
          <a:xfrm flipV="1">
            <a:off x="3790800" y="1265040"/>
            <a:ext cx="0" cy="7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432"/>
          <p:cNvSpPr/>
          <p:nvPr/>
        </p:nvSpPr>
        <p:spPr>
          <a:xfrm flipV="1">
            <a:off x="4248000" y="1265040"/>
            <a:ext cx="0" cy="7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433"/>
          <p:cNvSpPr/>
          <p:nvPr/>
        </p:nvSpPr>
        <p:spPr>
          <a:xfrm flipV="1">
            <a:off x="4705200" y="1265040"/>
            <a:ext cx="0" cy="7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434"/>
          <p:cNvSpPr/>
          <p:nvPr/>
        </p:nvSpPr>
        <p:spPr>
          <a:xfrm flipV="1">
            <a:off x="5162400" y="1265040"/>
            <a:ext cx="0" cy="7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435"/>
          <p:cNvSpPr/>
          <p:nvPr/>
        </p:nvSpPr>
        <p:spPr>
          <a:xfrm flipV="1">
            <a:off x="5619600" y="1265040"/>
            <a:ext cx="0" cy="7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436"/>
          <p:cNvSpPr/>
          <p:nvPr/>
        </p:nvSpPr>
        <p:spPr>
          <a:xfrm flipV="1">
            <a:off x="6076800" y="1265040"/>
            <a:ext cx="0" cy="75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450"/>
          <p:cNvSpPr/>
          <p:nvPr/>
        </p:nvSpPr>
        <p:spPr>
          <a:xfrm>
            <a:off x="1062000" y="1536840"/>
            <a:ext cx="50292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451"/>
          <p:cNvSpPr/>
          <p:nvPr/>
        </p:nvSpPr>
        <p:spPr>
          <a:xfrm>
            <a:off x="1046160" y="1490760"/>
            <a:ext cx="42840" cy="856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880" bIns="38880" anchor="ctr">
            <a:no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452"/>
          <p:cNvSpPr/>
          <p:nvPr/>
        </p:nvSpPr>
        <p:spPr>
          <a:xfrm>
            <a:off x="6089760" y="1494000"/>
            <a:ext cx="42840" cy="856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880" bIns="38880" anchor="ctr">
            <a:no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453"/>
          <p:cNvSpPr/>
          <p:nvPr/>
        </p:nvSpPr>
        <p:spPr>
          <a:xfrm>
            <a:off x="0" y="1430280"/>
            <a:ext cx="1100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Strid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455"/>
          <p:cNvSpPr/>
          <p:nvPr/>
        </p:nvSpPr>
        <p:spPr>
          <a:xfrm>
            <a:off x="1046160" y="1393920"/>
            <a:ext cx="4572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459"/>
          <p:cNvSpPr/>
          <p:nvPr/>
        </p:nvSpPr>
        <p:spPr>
          <a:xfrm>
            <a:off x="1655640" y="1473120"/>
            <a:ext cx="220680" cy="1071720"/>
          </a:xfrm>
          <a:prstGeom prst="rect">
            <a:avLst/>
          </a:prstGeom>
          <a:noFill/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650"/>
          <p:cNvSpPr/>
          <p:nvPr/>
        </p:nvSpPr>
        <p:spPr>
          <a:xfrm>
            <a:off x="657360" y="3390840"/>
            <a:ext cx="5629320" cy="173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Figure S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Schematic representation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VRN-H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intron 1 found in the barley CAP Core set (102 genotypes). Deletion types are named based on the first cultivar whose sequence was deposited in GenBank: Albacete (AY866494), Maskin (DQ924860), Morex (AY758233), OWB-D (AY750996), Triumph (AY871789) and Strider (AY750993). Edges of exons 1 and 2 are indicated by flanking black boxes. Gaps represent deletions (&gt;50 bp) relative to the full-length Strider allele. The 2.8 kb barley-wheat conserved region (dashed line) and the 436 bp vernalization critical region (dotted box) are indicated. Number of genotypes per deletion type is denote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438"/>
          <p:cNvSpPr/>
          <p:nvPr/>
        </p:nvSpPr>
        <p:spPr>
          <a:xfrm flipV="1">
            <a:off x="1062000" y="1677960"/>
            <a:ext cx="8319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439"/>
          <p:cNvSpPr/>
          <p:nvPr/>
        </p:nvSpPr>
        <p:spPr>
          <a:xfrm flipV="1">
            <a:off x="3559320" y="1677960"/>
            <a:ext cx="25416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462"/>
          <p:cNvSpPr/>
          <p:nvPr/>
        </p:nvSpPr>
        <p:spPr>
          <a:xfrm>
            <a:off x="1047600" y="1638360"/>
            <a:ext cx="42840" cy="856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880" bIns="38880" anchor="ctr">
            <a:no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464"/>
          <p:cNvSpPr/>
          <p:nvPr/>
        </p:nvSpPr>
        <p:spPr>
          <a:xfrm>
            <a:off x="6091200" y="1630440"/>
            <a:ext cx="42840" cy="856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880" bIns="38880" anchor="ctr">
            <a:no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454"/>
          <p:cNvSpPr/>
          <p:nvPr/>
        </p:nvSpPr>
        <p:spPr>
          <a:xfrm>
            <a:off x="1260360" y="2514600"/>
            <a:ext cx="989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36 bp vernalization critical region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457"/>
          <p:cNvSpPr/>
          <p:nvPr/>
        </p:nvSpPr>
        <p:spPr>
          <a:xfrm>
            <a:off x="812880" y="2338560"/>
            <a:ext cx="504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Exon 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458"/>
          <p:cNvSpPr/>
          <p:nvPr/>
        </p:nvSpPr>
        <p:spPr>
          <a:xfrm>
            <a:off x="5856120" y="2341440"/>
            <a:ext cx="513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Exon 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627"/>
          <p:cNvSpPr/>
          <p:nvPr/>
        </p:nvSpPr>
        <p:spPr>
          <a:xfrm>
            <a:off x="1641600" y="2341440"/>
            <a:ext cx="1279440" cy="180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  <a:headEnd len="med" type="arrow" w="med"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628"/>
          <p:cNvSpPr/>
          <p:nvPr/>
        </p:nvSpPr>
        <p:spPr>
          <a:xfrm>
            <a:off x="1801800" y="2305080"/>
            <a:ext cx="965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.8 kb barley-wheat conserved region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636"/>
          <p:cNvSpPr/>
          <p:nvPr/>
        </p:nvSpPr>
        <p:spPr>
          <a:xfrm>
            <a:off x="1440" y="1569960"/>
            <a:ext cx="1100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Albacet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637"/>
          <p:cNvSpPr/>
          <p:nvPr/>
        </p:nvSpPr>
        <p:spPr>
          <a:xfrm flipV="1">
            <a:off x="1062000" y="1824120"/>
            <a:ext cx="3650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638"/>
          <p:cNvSpPr/>
          <p:nvPr/>
        </p:nvSpPr>
        <p:spPr>
          <a:xfrm flipV="1">
            <a:off x="3638520" y="1824120"/>
            <a:ext cx="24591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639"/>
          <p:cNvSpPr/>
          <p:nvPr/>
        </p:nvSpPr>
        <p:spPr>
          <a:xfrm>
            <a:off x="1047600" y="1778040"/>
            <a:ext cx="42840" cy="856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880" bIns="38880" anchor="ctr">
            <a:no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640"/>
          <p:cNvSpPr/>
          <p:nvPr/>
        </p:nvSpPr>
        <p:spPr>
          <a:xfrm>
            <a:off x="6091200" y="1782720"/>
            <a:ext cx="42840" cy="856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880" bIns="38880" anchor="ctr">
            <a:no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641"/>
          <p:cNvSpPr/>
          <p:nvPr/>
        </p:nvSpPr>
        <p:spPr>
          <a:xfrm>
            <a:off x="-4680" y="1716120"/>
            <a:ext cx="1100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orex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652"/>
          <p:cNvSpPr/>
          <p:nvPr/>
        </p:nvSpPr>
        <p:spPr>
          <a:xfrm flipV="1">
            <a:off x="1062000" y="1967040"/>
            <a:ext cx="730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653"/>
          <p:cNvSpPr/>
          <p:nvPr/>
        </p:nvSpPr>
        <p:spPr>
          <a:xfrm>
            <a:off x="2901960" y="1965240"/>
            <a:ext cx="31957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654"/>
          <p:cNvSpPr/>
          <p:nvPr/>
        </p:nvSpPr>
        <p:spPr>
          <a:xfrm>
            <a:off x="1047600" y="1920960"/>
            <a:ext cx="42840" cy="856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880" bIns="38880" anchor="ctr">
            <a:no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655"/>
          <p:cNvSpPr/>
          <p:nvPr/>
        </p:nvSpPr>
        <p:spPr>
          <a:xfrm>
            <a:off x="6091200" y="1925640"/>
            <a:ext cx="42840" cy="856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880" bIns="38880" anchor="ctr">
            <a:no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656"/>
          <p:cNvSpPr/>
          <p:nvPr/>
        </p:nvSpPr>
        <p:spPr>
          <a:xfrm>
            <a:off x="-4680" y="1859040"/>
            <a:ext cx="1100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ask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8" name="Group 707"/>
          <p:cNvGrpSpPr/>
          <p:nvPr/>
        </p:nvGrpSpPr>
        <p:grpSpPr>
          <a:xfrm>
            <a:off x="1440" y="2009880"/>
            <a:ext cx="6132600" cy="215640"/>
            <a:chOff x="1440" y="2009880"/>
            <a:chExt cx="6132600" cy="215640"/>
          </a:xfrm>
        </p:grpSpPr>
        <p:sp>
          <p:nvSpPr>
            <p:cNvPr id="89" name="Text Box 708"/>
            <p:cNvSpPr/>
            <p:nvPr/>
          </p:nvSpPr>
          <p:spPr>
            <a:xfrm>
              <a:off x="1440" y="2009880"/>
              <a:ext cx="1100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Triump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709"/>
            <p:cNvSpPr/>
            <p:nvPr/>
          </p:nvSpPr>
          <p:spPr>
            <a:xfrm>
              <a:off x="1049400" y="2119320"/>
              <a:ext cx="29196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710"/>
            <p:cNvSpPr/>
            <p:nvPr/>
          </p:nvSpPr>
          <p:spPr>
            <a:xfrm>
              <a:off x="5556240" y="2119320"/>
              <a:ext cx="5475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711"/>
            <p:cNvSpPr/>
            <p:nvPr/>
          </p:nvSpPr>
          <p:spPr>
            <a:xfrm>
              <a:off x="1047600" y="2077920"/>
              <a:ext cx="42840" cy="853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520" bIns="38520" anchor="ctr">
              <a:no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712"/>
            <p:cNvSpPr/>
            <p:nvPr/>
          </p:nvSpPr>
          <p:spPr>
            <a:xfrm>
              <a:off x="6091200" y="2074680"/>
              <a:ext cx="42840" cy="853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520" bIns="38520" anchor="ctr">
              <a:no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4" name="Text Box 715"/>
          <p:cNvSpPr/>
          <p:nvPr/>
        </p:nvSpPr>
        <p:spPr>
          <a:xfrm>
            <a:off x="6134040" y="1430280"/>
            <a:ext cx="351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716"/>
          <p:cNvSpPr/>
          <p:nvPr/>
        </p:nvSpPr>
        <p:spPr>
          <a:xfrm>
            <a:off x="6140520" y="1569960"/>
            <a:ext cx="350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717"/>
          <p:cNvSpPr/>
          <p:nvPr/>
        </p:nvSpPr>
        <p:spPr>
          <a:xfrm>
            <a:off x="6134040" y="1716120"/>
            <a:ext cx="351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5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718"/>
          <p:cNvSpPr/>
          <p:nvPr/>
        </p:nvSpPr>
        <p:spPr>
          <a:xfrm>
            <a:off x="6134040" y="1862280"/>
            <a:ext cx="351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719"/>
          <p:cNvSpPr/>
          <p:nvPr/>
        </p:nvSpPr>
        <p:spPr>
          <a:xfrm>
            <a:off x="6134040" y="2008080"/>
            <a:ext cx="351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720"/>
          <p:cNvSpPr/>
          <p:nvPr/>
        </p:nvSpPr>
        <p:spPr>
          <a:xfrm>
            <a:off x="6134040" y="2160720"/>
            <a:ext cx="351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4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12-01T19:47:36Z</dcterms:created>
  <dc:creator>skinnerj</dc:creator>
  <dc:description/>
  <dc:language>en-US</dc:language>
  <cp:lastModifiedBy>marcosac</cp:lastModifiedBy>
  <dcterms:modified xsi:type="dcterms:W3CDTF">2010-11-07T20:45:10Z</dcterms:modified>
  <cp:revision>184</cp:revision>
  <dc:subject/>
  <dc:title>Slide 1</dc:title>
</cp:coreProperties>
</file>